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21" d="100"/>
          <a:sy n="121" d="100"/>
        </p:scale>
        <p:origin x="15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59340-CA90-4063-8044-43DC550A44B2}" type="datetimeFigureOut">
              <a:rPr lang="zh-CN" altLang="en-US" smtClean="0"/>
              <a:t>2024/5/27 Mon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A4BB0-0CD8-4C59-9D19-EEDD91A2C35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2645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59340-CA90-4063-8044-43DC550A44B2}" type="datetimeFigureOut">
              <a:rPr lang="zh-CN" altLang="en-US" smtClean="0"/>
              <a:t>2024/5/27 Mon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A4BB0-0CD8-4C59-9D19-EEDD91A2C35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247604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59340-CA90-4063-8044-43DC550A44B2}" type="datetimeFigureOut">
              <a:rPr lang="zh-CN" altLang="en-US" smtClean="0"/>
              <a:t>2024/5/27 Mon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A4BB0-0CD8-4C59-9D19-EEDD91A2C35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223938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59340-CA90-4063-8044-43DC550A44B2}" type="datetimeFigureOut">
              <a:rPr lang="zh-CN" altLang="en-US" smtClean="0"/>
              <a:t>2024/5/27 Mon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A4BB0-0CD8-4C59-9D19-EEDD91A2C35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84922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59340-CA90-4063-8044-43DC550A44B2}" type="datetimeFigureOut">
              <a:rPr lang="zh-CN" altLang="en-US" smtClean="0"/>
              <a:t>2024/5/27 Mon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A4BB0-0CD8-4C59-9D19-EEDD91A2C35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76533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59340-CA90-4063-8044-43DC550A44B2}" type="datetimeFigureOut">
              <a:rPr lang="zh-CN" altLang="en-US" smtClean="0"/>
              <a:t>2024/5/27 Mon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A4BB0-0CD8-4C59-9D19-EEDD91A2C35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089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59340-CA90-4063-8044-43DC550A44B2}" type="datetimeFigureOut">
              <a:rPr lang="zh-CN" altLang="en-US" smtClean="0"/>
              <a:t>2024/5/27 Monday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A4BB0-0CD8-4C59-9D19-EEDD91A2C35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62520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59340-CA90-4063-8044-43DC550A44B2}" type="datetimeFigureOut">
              <a:rPr lang="zh-CN" altLang="en-US" smtClean="0"/>
              <a:t>2024/5/27 Monday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A4BB0-0CD8-4C59-9D19-EEDD91A2C35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522516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59340-CA90-4063-8044-43DC550A44B2}" type="datetimeFigureOut">
              <a:rPr lang="zh-CN" altLang="en-US" smtClean="0"/>
              <a:t>2024/5/27 Monday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A4BB0-0CD8-4C59-9D19-EEDD91A2C35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69138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59340-CA90-4063-8044-43DC550A44B2}" type="datetimeFigureOut">
              <a:rPr lang="zh-CN" altLang="en-US" smtClean="0"/>
              <a:t>2024/5/27 Mon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A4BB0-0CD8-4C59-9D19-EEDD91A2C35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383772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59340-CA90-4063-8044-43DC550A44B2}" type="datetimeFigureOut">
              <a:rPr lang="zh-CN" altLang="en-US" smtClean="0"/>
              <a:t>2024/5/27 Mon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A4BB0-0CD8-4C59-9D19-EEDD91A2C35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563866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D59340-CA90-4063-8044-43DC550A44B2}" type="datetimeFigureOut">
              <a:rPr lang="zh-CN" altLang="en-US" smtClean="0"/>
              <a:t>2024/5/27 Mon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3A4BB0-0CD8-4C59-9D19-EEDD91A2C35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397388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标题 1"/>
          <p:cNvSpPr>
            <a:spLocks noGrp="1"/>
          </p:cNvSpPr>
          <p:nvPr>
            <p:ph type="title"/>
          </p:nvPr>
        </p:nvSpPr>
        <p:spPr>
          <a:xfrm>
            <a:off x="495299" y="5399087"/>
            <a:ext cx="10944335" cy="1325563"/>
          </a:xfrm>
        </p:spPr>
        <p:txBody>
          <a:bodyPr>
            <a:noAutofit/>
          </a:bodyPr>
          <a:lstStyle/>
          <a:p>
            <a:pPr algn="just"/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. The ROI (box) was deﬁned as the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bchondral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ancellous bone with a thickness of 0.4 mm located below the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bchondral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one plate to quantify the microarchitecture. 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5" descr="G:\博士资料\Osteoporosis Int 文章数据整理\Journal of Orthopaedic Surgery and Research 投稿\二修\Fig.S2.tif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17833" y="1671145"/>
            <a:ext cx="3899265" cy="3021538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0541733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33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宋体</vt:lpstr>
      <vt:lpstr>Arial</vt:lpstr>
      <vt:lpstr>Calibri</vt:lpstr>
      <vt:lpstr>Calibri Light</vt:lpstr>
      <vt:lpstr>Times New Roman</vt:lpstr>
      <vt:lpstr>Office 主题</vt:lpstr>
      <vt:lpstr>Fig. S2. The ROI (box) was deﬁned as the subchondral cancellous bone with a thickness of 0.4 mm located below the subchondral bone plate to quantify the microarchitecture. </vt:lpstr>
    </vt:vector>
  </TitlesOfParts>
  <Company>微软中国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. 2. Immunohistochemical staining for caspase-3, AGG, Col-II, MMP-13, and ADAMTS-4, and TUNEL assay in the cartilage of the right L4–5 FJs. Bars = 100 μm. Data are presented as the mean ± 95% CI. The ANOVA test was used to compare multiple means across different groups, followed by Fisher's LSD test to perform pairwise camparation for caspase-3, AGG, MMP-13, and TUNEL assay.</dc:title>
  <dc:creator>Yu Gou</dc:creator>
  <cp:lastModifiedBy>Yu Gou</cp:lastModifiedBy>
  <cp:revision>6</cp:revision>
  <dcterms:created xsi:type="dcterms:W3CDTF">2024-05-26T16:43:56Z</dcterms:created>
  <dcterms:modified xsi:type="dcterms:W3CDTF">2024-05-26T17:09:40Z</dcterms:modified>
</cp:coreProperties>
</file>